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F910D-62EB-40B3-AD19-F56ED6655B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DBDF7-7EFC-40E5-9398-700F5484F0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F7FE0-1C52-4F2D-BE0D-8619903D70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F0D08-DCCD-481C-9A2F-B57BDDE510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0634D-E893-460E-BBAE-0C086F95F8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9E5AD-2F4B-4CB7-A290-7309757E5C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EB742-C14F-47C9-A1D6-6635DC5EC6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A27E1-4548-4BC4-9BF6-06BE423798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B1745-74C4-43FC-9A44-1F9C038742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AA6C8-4705-4151-8D40-FE3432CDE6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9C6F8-EAC5-4EA0-A1ED-18197EE440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C9496-BD72-46BD-B2F0-B0C80A770D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BDACA6-152F-47E4-8A74-AD986C26DD9D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12960" y="615960"/>
          <a:ext cx="7445160" cy="5456160"/>
        </p:xfrm>
        <a:graphic>
          <a:graphicData uri="http://schemas.openxmlformats.org/drawingml/2006/table">
            <a:tbl>
              <a:tblPr/>
              <a:tblGrid>
                <a:gridCol w="628560"/>
                <a:gridCol w="3676680"/>
                <a:gridCol w="3139920"/>
              </a:tblGrid>
              <a:tr h="595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.n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Sample  (all HEV transfected cell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No. of virus copies /ml (Mean value from triplicate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595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ulture supernatant of 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Δ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SPR Huh7 cells (24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95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ulture supernatant of Huh7 cells (24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96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sate of 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Δ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SPR Huh7 cells (24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95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sate of  Huh7 cells (24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95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ulture supernatant of 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Δ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SPR Huh7 cells (72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95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ulture supernatant of Huh7 cells (72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954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sate of </a:t>
                      </a:r>
                      <a:r>
                        <a:rPr b="0" lang="el-G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Δ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SPR Huh7 cells (72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91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sate of Huh7 cells (72 hrs post transfection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6 x 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8-04T09:08:21Z</dcterms:created>
  <dc:creator>PG LAB</dc:creator>
  <dc:description/>
  <dc:language>en-US</dc:language>
  <cp:lastModifiedBy>PG LAB</cp:lastModifiedBy>
  <dcterms:modified xsi:type="dcterms:W3CDTF">2017-10-10T10:11:21Z</dcterms:modified>
  <cp:revision>3</cp:revision>
  <dc:subject/>
  <dc:title>Slide 1</dc:title>
</cp:coreProperties>
</file>